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505E3EF-67EA-436B-97B2-0124C06EBD24}" styleName="Medium Style 4 –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79" d="100"/>
          <a:sy n="79" d="100"/>
        </p:scale>
        <p:origin x="307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A11601-808F-3F51-A6E6-564D9A2298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55E064-9D89-1F6A-7740-37FE813FE8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4904D0-E2EA-12F9-CD7B-7933366266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52E65-A1E0-7D44-BC95-FE45BE83D8AA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80165F-9009-A3BA-D878-B8B10112F7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141686-200B-8111-CDF6-275BA2A9A0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B070D-9748-7E45-A421-4FCDAAC0DBF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16102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805C9C-8EB3-F1A0-D1DB-82BE82F388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8E62AA-592E-8437-B741-495D74348C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41582B-9731-F1CA-294E-BFA7C5CA9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52E65-A1E0-7D44-BC95-FE45BE83D8AA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D12765-37E8-9EAF-CB25-FFC32F70B8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849EAC-E08C-DC69-8DB0-7FBF97A8C6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B070D-9748-7E45-A421-4FCDAAC0DBF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813637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C2B67CA-128B-7BA4-6946-B276C5F830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DECE64-C55B-8293-9BCD-3ECD4C86C3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A0C963-3CC5-9345-EA79-D2E463F28D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52E65-A1E0-7D44-BC95-FE45BE83D8AA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3C9C71-8EEF-4E84-FEA2-0E449BAC1F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BC87CF-D439-1B7E-F8B3-1C45FC591E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B070D-9748-7E45-A421-4FCDAAC0DBF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30817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3E7F12-FF8D-D10A-6E4E-0EA5CC1B95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18EC11-C551-7DFF-A525-5C96A729D3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E52174-A17F-D2F9-64FB-C7D3E6BB1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52E65-A1E0-7D44-BC95-FE45BE83D8AA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F9C00E-9845-B445-5A9F-680D0FB94F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F1E0A7-CB57-001B-B2D6-B91D4D9B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B070D-9748-7E45-A421-4FCDAAC0DBF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928315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FB325F-4F01-A3A9-B7ED-916FA0075E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306D1F-A77C-9DA0-4F92-BF28D0EF79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B60B46-C8DA-EFCD-D9B2-1471ADA3BE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52E65-A1E0-7D44-BC95-FE45BE83D8AA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06FC09-C372-3A89-40B8-566F37CB2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D0FABC-1F64-0A10-DB8B-096A5C6DF9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B070D-9748-7E45-A421-4FCDAAC0DBF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88941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B5CCA5-C688-1C97-CB09-6BB3858D84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BF7D20-5E21-E0C9-BEA5-3FEF4931B4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710007-16C7-499C-1801-0D0DA26B5A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93B92D-DD53-DC16-0643-1C5DD6BE11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52E65-A1E0-7D44-BC95-FE45BE83D8AA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043277-185A-5908-F683-27D3BE800C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F5A667-D4B1-BD0F-6704-A6636D171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B070D-9748-7E45-A421-4FCDAAC0DBF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49149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8C1794-2D7E-B8D2-37F2-892798D0BB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D9DC17-34D9-A0BB-9476-9201D78C41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44E465-EEF1-80CF-94BD-3A90EBE1B3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7671472-FACC-A662-8081-0034AC0ADA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5AA9846-C3DA-F2E4-C9B2-1395947478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F554213-AB61-D11C-5B28-6C136D3212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52E65-A1E0-7D44-BC95-FE45BE83D8AA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9428C6E-5165-EE4A-D6DA-DDBEC07C61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9D13BF-CE82-5143-6DB1-BCCA9764E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B070D-9748-7E45-A421-4FCDAAC0DBF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62414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696C0C-9E1F-3E1E-909D-B44FD7E55C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2F50C41-81F2-C1D3-91FC-308A9A22FC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52E65-A1E0-7D44-BC95-FE45BE83D8AA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31AB85E-2CB6-9F58-6104-B00C365DCA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848197F-D48A-4855-962C-62D2B27D3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B070D-9748-7E45-A421-4FCDAAC0DBF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20287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9FA00D2-BD53-FDA8-163D-95C35A1ED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52E65-A1E0-7D44-BC95-FE45BE83D8AA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95B72CA-1907-F55C-162B-F2587F8C3C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444D95A-F63F-44EC-C6E3-CAEF9196C4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B070D-9748-7E45-A421-4FCDAAC0DBF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164144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C66F6A-B749-57AA-0BA4-691CF06099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3DED9D-A92E-06CC-9DA5-ED97B08CF2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5B5EAB-75FB-FDDD-3E3E-DB257E786C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29D9D1-BAA0-8510-43F9-DC895B6E63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52E65-A1E0-7D44-BC95-FE45BE83D8AA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5B5313-26CE-AAF0-85AF-A231AA62CD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ED860E-AB41-9C10-A0F3-76A68EACD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B070D-9748-7E45-A421-4FCDAAC0DBF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00593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8AF571-9CFE-644E-16F5-4A5E68C03C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735E90-CA01-91C4-087E-A815FB483C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21C432-99D9-C25B-E34F-65E72FA35C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18D576-BF56-A092-DB3B-2CFC44A04A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52E65-A1E0-7D44-BC95-FE45BE83D8AA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51379F-5F1E-27B8-014C-DD27C73F5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894BE6-16C8-C72A-0EF1-B395999A1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B070D-9748-7E45-A421-4FCDAAC0DBF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20464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CB87E8-6DAC-6B65-F3E9-6C215364DF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0FA02E-B7C7-D785-C69D-36133625A8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FF44FE-7D8B-156A-39F9-9890ECCDC3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0052E65-A1E0-7D44-BC95-FE45BE83D8AA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C53B3C-92DE-5D94-B3DD-30CF74D4D5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CEC3CF-0FFE-9AF7-B219-2ED4287A93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C6B070D-9748-7E45-A421-4FCDAAC0DBF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230497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4A890B6-375D-B29D-D044-57721FCAAF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2671869"/>
              </p:ext>
            </p:extLst>
          </p:nvPr>
        </p:nvGraphicFramePr>
        <p:xfrm>
          <a:off x="2355020" y="1144162"/>
          <a:ext cx="7524705" cy="2279777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869472">
                  <a:extLst>
                    <a:ext uri="{9D8B030D-6E8A-4147-A177-3AD203B41FA5}">
                      <a16:colId xmlns:a16="http://schemas.microsoft.com/office/drawing/2014/main" val="1763636076"/>
                    </a:ext>
                  </a:extLst>
                </a:gridCol>
                <a:gridCol w="1201999">
                  <a:extLst>
                    <a:ext uri="{9D8B030D-6E8A-4147-A177-3AD203B41FA5}">
                      <a16:colId xmlns:a16="http://schemas.microsoft.com/office/drawing/2014/main" val="1846625663"/>
                    </a:ext>
                  </a:extLst>
                </a:gridCol>
                <a:gridCol w="854771">
                  <a:extLst>
                    <a:ext uri="{9D8B030D-6E8A-4147-A177-3AD203B41FA5}">
                      <a16:colId xmlns:a16="http://schemas.microsoft.com/office/drawing/2014/main" val="1177768892"/>
                    </a:ext>
                  </a:extLst>
                </a:gridCol>
                <a:gridCol w="1231682">
                  <a:extLst>
                    <a:ext uri="{9D8B030D-6E8A-4147-A177-3AD203B41FA5}">
                      <a16:colId xmlns:a16="http://schemas.microsoft.com/office/drawing/2014/main" val="705495950"/>
                    </a:ext>
                  </a:extLst>
                </a:gridCol>
                <a:gridCol w="1240604">
                  <a:extLst>
                    <a:ext uri="{9D8B030D-6E8A-4147-A177-3AD203B41FA5}">
                      <a16:colId xmlns:a16="http://schemas.microsoft.com/office/drawing/2014/main" val="2546560126"/>
                    </a:ext>
                  </a:extLst>
                </a:gridCol>
                <a:gridCol w="1039586">
                  <a:extLst>
                    <a:ext uri="{9D8B030D-6E8A-4147-A177-3AD203B41FA5}">
                      <a16:colId xmlns:a16="http://schemas.microsoft.com/office/drawing/2014/main" val="346873"/>
                    </a:ext>
                  </a:extLst>
                </a:gridCol>
                <a:gridCol w="896774">
                  <a:extLst>
                    <a:ext uri="{9D8B030D-6E8A-4147-A177-3AD203B41FA5}">
                      <a16:colId xmlns:a16="http://schemas.microsoft.com/office/drawing/2014/main" val="3414213260"/>
                    </a:ext>
                  </a:extLst>
                </a:gridCol>
                <a:gridCol w="189817">
                  <a:extLst>
                    <a:ext uri="{9D8B030D-6E8A-4147-A177-3AD203B41FA5}">
                      <a16:colId xmlns:a16="http://schemas.microsoft.com/office/drawing/2014/main" val="2098439658"/>
                    </a:ext>
                  </a:extLst>
                </a:gridCol>
              </a:tblGrid>
              <a:tr h="1066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1000" kern="100">
                          <a:effectLst/>
                        </a:rPr>
                        <a:t>GO ID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1000" kern="100">
                          <a:effectLst/>
                        </a:rPr>
                        <a:t>GO Term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1000" kern="100">
                          <a:effectLst/>
                        </a:rPr>
                        <a:t>Number of genes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1000" kern="100">
                          <a:effectLst/>
                        </a:rPr>
                        <a:t>Fold enrichment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1000" kern="100" dirty="0">
                          <a:effectLst/>
                        </a:rPr>
                        <a:t>Genes in GO Term</a:t>
                      </a:r>
                      <a:endParaRPr lang="en-DE" sz="1000" kern="100" dirty="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1000" kern="100" dirty="0">
                          <a:effectLst/>
                        </a:rPr>
                        <a:t>p-value</a:t>
                      </a:r>
                      <a:endParaRPr lang="en-DE" sz="1000" kern="100" dirty="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1200" kern="100">
                          <a:effectLst/>
                        </a:rPr>
                        <a:t>A</a:t>
                      </a:r>
                      <a:r>
                        <a:rPr lang="en-US" sz="1000" kern="100">
                          <a:effectLst/>
                        </a:rPr>
                        <a:t>nalysis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17419647"/>
                  </a:ext>
                </a:extLst>
              </a:tr>
              <a:tr h="218440"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GO:000695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Response to stress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105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1.5</a:t>
                      </a:r>
                      <a:endParaRPr lang="en-DE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615</a:t>
                      </a:r>
                      <a:endParaRPr lang="en-DE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9.47e-6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BP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7758240"/>
                  </a:ext>
                </a:extLst>
              </a:tr>
              <a:tr h="218440"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GO:0006984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ER-nucleus signaling pathway</a:t>
                      </a:r>
                      <a:endParaRPr lang="en-DE" sz="1000" kern="100" dirty="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5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4.41</a:t>
                      </a:r>
                      <a:endParaRPr lang="en-DE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10</a:t>
                      </a:r>
                      <a:endParaRPr lang="en-DE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2.99e-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BP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DE" sz="1000" kern="100">
                          <a:effectLst/>
                        </a:rPr>
                        <a:t> 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497212020"/>
                  </a:ext>
                </a:extLst>
              </a:tr>
              <a:tr h="218440"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GO:000681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Transport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179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1.19</a:t>
                      </a:r>
                      <a:endParaRPr lang="en-DE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1323</a:t>
                      </a:r>
                      <a:endParaRPr lang="en-DE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5.60e-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BP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21492940"/>
                  </a:ext>
                </a:extLst>
              </a:tr>
              <a:tr h="218440"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GO:0071692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Protein localisation to extracellular region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6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3.31</a:t>
                      </a:r>
                      <a:endParaRPr lang="en-DE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16</a:t>
                      </a:r>
                      <a:endParaRPr lang="en-DE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6.18e-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BP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53731834"/>
                  </a:ext>
                </a:extLst>
              </a:tr>
              <a:tr h="218440"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GO:0006508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Proteolysis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4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1.36</a:t>
                      </a:r>
                      <a:endParaRPr lang="en-DE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259</a:t>
                      </a:r>
                      <a:endParaRPr lang="en-DE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2.64e-2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r>
                        <a:rPr lang="en-US" sz="1200" kern="100">
                          <a:effectLst/>
                        </a:rPr>
                        <a:t>BP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53550681"/>
                  </a:ext>
                </a:extLst>
              </a:tr>
              <a:tr h="218440"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GO:0016021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Integral component of membrane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287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1.19</a:t>
                      </a:r>
                      <a:endParaRPr lang="en-DE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2094</a:t>
                      </a:r>
                      <a:endParaRPr lang="en-DE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4.99e-4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CC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4757820"/>
                  </a:ext>
                </a:extLst>
              </a:tr>
              <a:tr h="218440"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GO:000032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Lytic vacuole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28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1.78</a:t>
                      </a:r>
                      <a:endParaRPr lang="en-DE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139</a:t>
                      </a:r>
                      <a:endParaRPr lang="en-DE" dirty="0"/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1000" kern="100">
                          <a:effectLst/>
                        </a:rPr>
                        <a:t>1.73e-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r>
                        <a:rPr lang="en-US" sz="1000" kern="100" dirty="0">
                          <a:effectLst/>
                        </a:rPr>
                        <a:t>CC</a:t>
                      </a:r>
                      <a:endParaRPr lang="en-DE" sz="1000" kern="100" dirty="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84153334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A9C264F6-4D92-A0BB-AAB1-6B06A314C2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49917" y="573330"/>
            <a:ext cx="7629808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DE" sz="1000" b="1" dirty="0"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7 (</a:t>
            </a:r>
            <a:r>
              <a:rPr lang="en-US" altLang="en-DE" sz="1000" b="1" dirty="0" err="1"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altLang="en-DE" sz="1000" b="1" dirty="0"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kumimoji="0" lang="en-US" altLang="en-D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kumimoji="0" lang="en-US" altLang="en-D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Selection of Gene Ontology (GO) Terms Biological Processes (BP) or cell component (CC) upregulated from a low stringency analysis in the collagen secreting strain TM30.4 relative to the expression host FGE2.1 at 18h after cultivation.</a:t>
            </a:r>
            <a:endParaRPr kumimoji="0" lang="en-US" altLang="en-D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19933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28FE474-23A0-E376-FBC7-E51E1D01FD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4087255"/>
              </p:ext>
            </p:extLst>
          </p:nvPr>
        </p:nvGraphicFramePr>
        <p:xfrm>
          <a:off x="2082486" y="689001"/>
          <a:ext cx="7923367" cy="5364861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1424674">
                  <a:extLst>
                    <a:ext uri="{9D8B030D-6E8A-4147-A177-3AD203B41FA5}">
                      <a16:colId xmlns:a16="http://schemas.microsoft.com/office/drawing/2014/main" val="3266223176"/>
                    </a:ext>
                  </a:extLst>
                </a:gridCol>
                <a:gridCol w="986374">
                  <a:extLst>
                    <a:ext uri="{9D8B030D-6E8A-4147-A177-3AD203B41FA5}">
                      <a16:colId xmlns:a16="http://schemas.microsoft.com/office/drawing/2014/main" val="3361845307"/>
                    </a:ext>
                  </a:extLst>
                </a:gridCol>
                <a:gridCol w="986374">
                  <a:extLst>
                    <a:ext uri="{9D8B030D-6E8A-4147-A177-3AD203B41FA5}">
                      <a16:colId xmlns:a16="http://schemas.microsoft.com/office/drawing/2014/main" val="3164718669"/>
                    </a:ext>
                  </a:extLst>
                </a:gridCol>
                <a:gridCol w="4525945">
                  <a:extLst>
                    <a:ext uri="{9D8B030D-6E8A-4147-A177-3AD203B41FA5}">
                      <a16:colId xmlns:a16="http://schemas.microsoft.com/office/drawing/2014/main" val="2763893776"/>
                    </a:ext>
                  </a:extLst>
                </a:gridCol>
              </a:tblGrid>
              <a:tr h="10458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GO Term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Gen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Gene nam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Description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607919727"/>
                  </a:ext>
                </a:extLst>
              </a:tr>
              <a:tr h="10913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Response to stress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545466581"/>
                  </a:ext>
                </a:extLst>
              </a:tr>
              <a:tr h="25540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2g0288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-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 dirty="0">
                          <a:effectLst/>
                        </a:rPr>
                        <a:t>Ortholog(s) have GTPase activity, role in Golgi to plasma membrane protein transport, cellular response to drug, endocytosis, protein targeting to vacuole and cytosol, trans-Golgi network localization</a:t>
                      </a:r>
                      <a:endParaRPr lang="en-DE" sz="800" kern="100" dirty="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2185087026"/>
                  </a:ext>
                </a:extLst>
              </a:tr>
              <a:tr h="10458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2g0583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mpdA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Mannitol 1-phosphate dehydrogenas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3153813277"/>
                  </a:ext>
                </a:extLst>
              </a:tr>
              <a:tr h="127702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18g0617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mkkA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MAP kinase kinase (MAPKK) with a predicted role in the cell wall integrity pathway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3626120599"/>
                  </a:ext>
                </a:extLst>
              </a:tr>
              <a:tr h="25995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3g0266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dscA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Ortholog(s) have ubiquitin protein ligase activity and role in protein localization to Golgi apparatus, protein processing, protein ubiquitination, ubiquitin-dependent protein catabolic process via the multivesicular body sorting pathway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2016418861"/>
                  </a:ext>
                </a:extLst>
              </a:tr>
              <a:tr h="1686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4g0744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shrA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ER packaging chaperone with a predicted role in the incorporation of amino acid permeases into COPII-coated vesicl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210470547"/>
                  </a:ext>
                </a:extLst>
              </a:tr>
              <a:tr h="127702">
                <a:tc gridSpan="3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Integral component of membran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2621829978"/>
                  </a:ext>
                </a:extLst>
              </a:tr>
              <a:tr h="21410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2g02340</a:t>
                      </a:r>
                      <a:br>
                        <a:rPr lang="en-US" sz="800" kern="100">
                          <a:effectLst/>
                        </a:rPr>
                      </a:br>
                      <a:r>
                        <a:rPr lang="en-US" sz="800" kern="100">
                          <a:effectLst/>
                        </a:rPr>
                        <a:t>An02g0236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chsL</a:t>
                      </a:r>
                      <a:br>
                        <a:rPr lang="en-US" sz="800" kern="100">
                          <a:effectLst/>
                        </a:rPr>
                      </a:br>
                      <a:r>
                        <a:rPr lang="en-US" sz="800" kern="100">
                          <a:effectLst/>
                        </a:rPr>
                        <a:t>chsM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 dirty="0">
                          <a:effectLst/>
                        </a:rPr>
                        <a:t>Putative chitin synthase</a:t>
                      </a:r>
                      <a:endParaRPr lang="en-DE" sz="800" kern="100" dirty="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604883628"/>
                  </a:ext>
                </a:extLst>
              </a:tr>
              <a:tr h="127702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2g0398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kslA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Putative beta-glucanas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3749285564"/>
                  </a:ext>
                </a:extLst>
              </a:tr>
              <a:tr h="127702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Transport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3525305135"/>
                  </a:ext>
                </a:extLst>
              </a:tr>
              <a:tr h="10458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1g1163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sec61a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Putative SEC61 complex subunit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1884475196"/>
                  </a:ext>
                </a:extLst>
              </a:tr>
              <a:tr h="10913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8g1027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tg2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Putative membrane protein involved in autophagy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3616219108"/>
                  </a:ext>
                </a:extLst>
              </a:tr>
              <a:tr h="25540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17g0144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pex3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Ortholog(s) have protein binding, bridging activity and role in ER-dependent peroxisome organization, fatty acid metabolic process, hyphal growth, peroxisome inheritance, protein import into peroxisome membran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2200993662"/>
                  </a:ext>
                </a:extLst>
              </a:tr>
              <a:tr h="25540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2g0869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-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Has domain(s) with predicted substrate-specific transmembrane transporter activity, transmembrane transporter activity, transporter activity, role in transmembrane transport and integral component of membrane, membrane localization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1121618937"/>
                  </a:ext>
                </a:extLst>
              </a:tr>
              <a:tr h="25540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2g0946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-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Ortholog(s) have phosphatidylinositol-3-phosphate binding activity and role in Golgi to endosome transport, Golgi to vacuole transport, vacuole inheritance, vesicle docking involved in exocytosis, vesicle fusion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3169060735"/>
                  </a:ext>
                </a:extLst>
              </a:tr>
              <a:tr h="127702">
                <a:tc gridSpan="3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Protein localisation to extracellular region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938358708"/>
                  </a:ext>
                </a:extLst>
              </a:tr>
              <a:tr h="25995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2g0288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-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Ortholog(s) have GTPase activity, role in Golgi to plasma membrane protein transport, cellular response to drug, endocytosis, protein targeting to vacuole and cytosol, trans-Golgi network localization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3486559074"/>
                  </a:ext>
                </a:extLst>
              </a:tr>
              <a:tr h="25540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3g0486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nce102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Ortholog(s) have role in actin cytoskeleton organization, asexual sporulation resulting in formation of a cellular spore, eisosome assembly and establishment of protein localization to plasma membrane, mor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3889535781"/>
                  </a:ext>
                </a:extLst>
              </a:tr>
              <a:tr h="10458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7g1000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-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Has domain(s) with predicted role in protein secretion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2545469173"/>
                  </a:ext>
                </a:extLst>
              </a:tr>
              <a:tr h="10913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14g0001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srgA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Putative Rab GTPas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2164590574"/>
                  </a:ext>
                </a:extLst>
              </a:tr>
              <a:tr h="104587">
                <a:tc gridSpan="3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Proteolysis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2968291855"/>
                  </a:ext>
                </a:extLst>
              </a:tr>
              <a:tr h="10458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18g0670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pre7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20S CP beta subunit of the proteasom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162140611"/>
                  </a:ext>
                </a:extLst>
              </a:tr>
              <a:tr h="25540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8g0043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kexA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Ortholog(s) have serine-type carboxypeptidase activity, role in apoptotic process, hyphal growth, positive regulation of conidium formation and fungal-type vacuole, trans-Golgi network localization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3623406363"/>
                  </a:ext>
                </a:extLst>
              </a:tr>
              <a:tr h="10913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7g0388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pepC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Putative vacuolar serine proteinas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3381552525"/>
                  </a:ext>
                </a:extLst>
              </a:tr>
              <a:tr h="10458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8g0449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protA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Secreted lysosomal Pro-Xaa carboxypeptidas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3533152096"/>
                  </a:ext>
                </a:extLst>
              </a:tr>
              <a:tr h="10913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An03g0520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protF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US" sz="800" kern="100" dirty="0">
                          <a:effectLst/>
                        </a:rPr>
                        <a:t>Carboxypeptidase Y family secreted protease</a:t>
                      </a:r>
                      <a:endParaRPr lang="en-DE" sz="800" kern="100" dirty="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0925" marR="40925" marT="0" marB="0"/>
                </a:tc>
                <a:extLst>
                  <a:ext uri="{0D108BD9-81ED-4DB2-BD59-A6C34878D82A}">
                    <a16:rowId xmlns:a16="http://schemas.microsoft.com/office/drawing/2014/main" val="374181474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31645140-648E-53E3-7440-46A308AA4F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2486" y="186200"/>
            <a:ext cx="792336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DE" sz="1000" b="1" dirty="0"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7(ii)</a:t>
            </a:r>
            <a:r>
              <a:rPr kumimoji="0" lang="en-US" altLang="en-D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kumimoji="0" lang="en-US" altLang="en-D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Selection of Gene Ontology (GO) Terms (Biological Processes and Cell Component) upregulated from a low stringency analysis in the collagen secreting strain TM30.4 relative to the expression host FGE2.1 at 18h after cultivation.</a:t>
            </a:r>
            <a:endParaRPr kumimoji="0" lang="en-US" altLang="en-D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71459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AA192BC-D1C8-DE7C-2BAE-DC59BC15B5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293948"/>
              </p:ext>
            </p:extLst>
          </p:nvPr>
        </p:nvGraphicFramePr>
        <p:xfrm>
          <a:off x="2668296" y="892412"/>
          <a:ext cx="6329892" cy="4050919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723900">
                  <a:extLst>
                    <a:ext uri="{9D8B030D-6E8A-4147-A177-3AD203B41FA5}">
                      <a16:colId xmlns:a16="http://schemas.microsoft.com/office/drawing/2014/main" val="2512001050"/>
                    </a:ext>
                  </a:extLst>
                </a:gridCol>
                <a:gridCol w="450215">
                  <a:extLst>
                    <a:ext uri="{9D8B030D-6E8A-4147-A177-3AD203B41FA5}">
                      <a16:colId xmlns:a16="http://schemas.microsoft.com/office/drawing/2014/main" val="238981905"/>
                    </a:ext>
                  </a:extLst>
                </a:gridCol>
                <a:gridCol w="989965">
                  <a:extLst>
                    <a:ext uri="{9D8B030D-6E8A-4147-A177-3AD203B41FA5}">
                      <a16:colId xmlns:a16="http://schemas.microsoft.com/office/drawing/2014/main" val="4235293870"/>
                    </a:ext>
                  </a:extLst>
                </a:gridCol>
                <a:gridCol w="540385">
                  <a:extLst>
                    <a:ext uri="{9D8B030D-6E8A-4147-A177-3AD203B41FA5}">
                      <a16:colId xmlns:a16="http://schemas.microsoft.com/office/drawing/2014/main" val="1218598876"/>
                    </a:ext>
                  </a:extLst>
                </a:gridCol>
                <a:gridCol w="450215">
                  <a:extLst>
                    <a:ext uri="{9D8B030D-6E8A-4147-A177-3AD203B41FA5}">
                      <a16:colId xmlns:a16="http://schemas.microsoft.com/office/drawing/2014/main" val="3467512472"/>
                    </a:ext>
                  </a:extLst>
                </a:gridCol>
                <a:gridCol w="361950">
                  <a:extLst>
                    <a:ext uri="{9D8B030D-6E8A-4147-A177-3AD203B41FA5}">
                      <a16:colId xmlns:a16="http://schemas.microsoft.com/office/drawing/2014/main" val="2706296399"/>
                    </a:ext>
                  </a:extLst>
                </a:gridCol>
                <a:gridCol w="167887">
                  <a:extLst>
                    <a:ext uri="{9D8B030D-6E8A-4147-A177-3AD203B41FA5}">
                      <a16:colId xmlns:a16="http://schemas.microsoft.com/office/drawing/2014/main" val="1992730131"/>
                    </a:ext>
                  </a:extLst>
                </a:gridCol>
                <a:gridCol w="424815">
                  <a:extLst>
                    <a:ext uri="{9D8B030D-6E8A-4147-A177-3AD203B41FA5}">
                      <a16:colId xmlns:a16="http://schemas.microsoft.com/office/drawing/2014/main" val="4081413527"/>
                    </a:ext>
                  </a:extLst>
                </a:gridCol>
                <a:gridCol w="167887">
                  <a:extLst>
                    <a:ext uri="{9D8B030D-6E8A-4147-A177-3AD203B41FA5}">
                      <a16:colId xmlns:a16="http://schemas.microsoft.com/office/drawing/2014/main" val="2274651146"/>
                    </a:ext>
                  </a:extLst>
                </a:gridCol>
                <a:gridCol w="450215">
                  <a:extLst>
                    <a:ext uri="{9D8B030D-6E8A-4147-A177-3AD203B41FA5}">
                      <a16:colId xmlns:a16="http://schemas.microsoft.com/office/drawing/2014/main" val="2721228532"/>
                    </a:ext>
                  </a:extLst>
                </a:gridCol>
                <a:gridCol w="167887">
                  <a:extLst>
                    <a:ext uri="{9D8B030D-6E8A-4147-A177-3AD203B41FA5}">
                      <a16:colId xmlns:a16="http://schemas.microsoft.com/office/drawing/2014/main" val="3302673169"/>
                    </a:ext>
                  </a:extLst>
                </a:gridCol>
                <a:gridCol w="167887">
                  <a:extLst>
                    <a:ext uri="{9D8B030D-6E8A-4147-A177-3AD203B41FA5}">
                      <a16:colId xmlns:a16="http://schemas.microsoft.com/office/drawing/2014/main" val="1219656313"/>
                    </a:ext>
                  </a:extLst>
                </a:gridCol>
                <a:gridCol w="167887">
                  <a:extLst>
                    <a:ext uri="{9D8B030D-6E8A-4147-A177-3AD203B41FA5}">
                      <a16:colId xmlns:a16="http://schemas.microsoft.com/office/drawing/2014/main" val="2985861517"/>
                    </a:ext>
                  </a:extLst>
                </a:gridCol>
                <a:gridCol w="167887">
                  <a:extLst>
                    <a:ext uri="{9D8B030D-6E8A-4147-A177-3AD203B41FA5}">
                      <a16:colId xmlns:a16="http://schemas.microsoft.com/office/drawing/2014/main" val="3260789401"/>
                    </a:ext>
                  </a:extLst>
                </a:gridCol>
                <a:gridCol w="450215">
                  <a:extLst>
                    <a:ext uri="{9D8B030D-6E8A-4147-A177-3AD203B41FA5}">
                      <a16:colId xmlns:a16="http://schemas.microsoft.com/office/drawing/2014/main" val="419666589"/>
                    </a:ext>
                  </a:extLst>
                </a:gridCol>
                <a:gridCol w="480695">
                  <a:extLst>
                    <a:ext uri="{9D8B030D-6E8A-4147-A177-3AD203B41FA5}">
                      <a16:colId xmlns:a16="http://schemas.microsoft.com/office/drawing/2014/main" val="82120873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Gene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Gene name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Description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15h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18h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21h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</a:pPr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656598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ERAD components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 dirty="0">
                          <a:effectLst/>
                        </a:rPr>
                        <a:t> </a:t>
                      </a:r>
                      <a:endParaRPr lang="en-DE" sz="1000" kern="100" dirty="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Mean count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Log</a:t>
                      </a:r>
                      <a:r>
                        <a:rPr lang="en-US" sz="800" kern="100" baseline="-25000">
                          <a:effectLst/>
                        </a:rPr>
                        <a:t>2</a:t>
                      </a:r>
                      <a:r>
                        <a:rPr lang="en-US" sz="800" kern="100">
                          <a:effectLst/>
                        </a:rPr>
                        <a:t> Fold change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p-value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Mean count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Log</a:t>
                      </a:r>
                      <a:r>
                        <a:rPr lang="en-US" sz="800" kern="100" baseline="-25000">
                          <a:effectLst/>
                        </a:rPr>
                        <a:t>2</a:t>
                      </a:r>
                      <a:r>
                        <a:rPr lang="en-US" sz="800" kern="100">
                          <a:effectLst/>
                        </a:rPr>
                        <a:t> Fold change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p-value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Mean count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Log</a:t>
                      </a:r>
                      <a:r>
                        <a:rPr lang="en-US" sz="800" kern="100" baseline="-25000">
                          <a:effectLst/>
                        </a:rPr>
                        <a:t>2</a:t>
                      </a:r>
                      <a:r>
                        <a:rPr lang="en-US" sz="800" kern="100">
                          <a:effectLst/>
                        </a:rPr>
                        <a:t> Fold change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p-value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517114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An15g0064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derA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Putative ER associated protein degradation protein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176.5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0.48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48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128.95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0.58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07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118.26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1.38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3.2e-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872878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An03g0460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doaA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effectLst/>
                        </a:rPr>
                        <a:t>ERAD factor</a:t>
                      </a:r>
                      <a:endParaRPr lang="en-DE" sz="1000" kern="100" dirty="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3914.1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25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72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3459.78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2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19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2080.59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6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5.4e-2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753876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An01g1272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hrdC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Putative ubiquitin-protein ligase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2384.68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22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77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1987.84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09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62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1342.3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02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96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908585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An01g1410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mifA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putative ERAD component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437.31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09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9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268.52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0.97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5.15e-5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171.07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1.26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2.95e-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298140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An18g0622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mnsA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putative ERAD component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956.27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19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81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620.4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0.4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1.9e-2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693.21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1.46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4.31e-6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373462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UPR components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431892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An11g0418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bipA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DnaK-type molecular chaperone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9887.0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5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41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5519.6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0.76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2.64e-7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3603.7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1.5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4.34e-7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346928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An02g1480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pdiA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protein disulfide isomerase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5572.18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17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84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3257.3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0.5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2.04e-4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3343.32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1.41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7.64e-7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630502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An01g0842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clxA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Putative calnexin, integral membrane ER chaperone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6967.47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49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46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3721.0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0.92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6.74e-11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3515.19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1.6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6.26e-8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051423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An01g0460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prpA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Protein disulfide isomerase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1112.32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44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54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622.58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1.04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4.62e-9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502.66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1.51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6.08e-6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912291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An18g0202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tigA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Protein disulfide isomerase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3832.81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9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08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2421.19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0.1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44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1875.69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0.56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11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254629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An01g0016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hacA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Transcription factor UPR mediator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6039.81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37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5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5736.90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22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0.1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6059.63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-0.46</a:t>
                      </a:r>
                      <a:endParaRPr lang="en-DE" sz="10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 dirty="0">
                          <a:effectLst/>
                        </a:rPr>
                        <a:t>0.22</a:t>
                      </a:r>
                      <a:endParaRPr lang="en-DE" sz="1000" kern="100" dirty="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22293518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47E4A405-84D3-3CB6-C93A-40BE49CAC3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83684" y="185106"/>
            <a:ext cx="6414504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DE" sz="1000" b="1" dirty="0"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7 (iii)</a:t>
            </a:r>
            <a:r>
              <a:rPr kumimoji="0" lang="en-US" altLang="en-D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kumimoji="0" lang="en-US" altLang="en-D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A list of </a:t>
            </a:r>
            <a:r>
              <a:rPr kumimoji="0" lang="en-US" altLang="en-DE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kumimoji="0" lang="en-US" altLang="en-DE" sz="10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niger</a:t>
            </a:r>
            <a:r>
              <a:rPr kumimoji="0" lang="en-US" altLang="en-DE" sz="10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altLang="en-D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genes involved in ERAD and UPR. Green shading implies upregulated and red downregulated, only where multiple hypothesis corrected p-value is less than 0.05.</a:t>
            </a:r>
            <a:endParaRPr kumimoji="0" lang="en-US" altLang="en-D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675405A-0A95-4417-BE22-1CB62A24B2A6}"/>
              </a:ext>
            </a:extLst>
          </p:cNvPr>
          <p:cNvSpPr txBox="1"/>
          <p:nvPr/>
        </p:nvSpPr>
        <p:spPr>
          <a:xfrm>
            <a:off x="2655652" y="5077838"/>
            <a:ext cx="648031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AU" sz="1000" dirty="0"/>
              <a:t>Carvalho ND, </a:t>
            </a:r>
            <a:r>
              <a:rPr lang="en-AU" sz="1000" dirty="0" err="1"/>
              <a:t>Arentshorst</a:t>
            </a:r>
            <a:r>
              <a:rPr lang="en-AU" sz="1000" dirty="0"/>
              <a:t> M, </a:t>
            </a:r>
            <a:r>
              <a:rPr lang="en-AU" sz="1000" dirty="0" err="1"/>
              <a:t>Kooistra</a:t>
            </a:r>
            <a:r>
              <a:rPr lang="en-AU" sz="1000" dirty="0"/>
              <a:t> R, Stam H, </a:t>
            </a:r>
            <a:r>
              <a:rPr lang="en-AU" sz="1000" dirty="0" err="1"/>
              <a:t>Sagt</a:t>
            </a:r>
            <a:r>
              <a:rPr lang="en-AU" sz="1000" dirty="0"/>
              <a:t> CM, van den </a:t>
            </a:r>
            <a:r>
              <a:rPr lang="en-AU" sz="1000" dirty="0" err="1"/>
              <a:t>Hondel</a:t>
            </a:r>
            <a:r>
              <a:rPr lang="en-AU" sz="1000" dirty="0"/>
              <a:t> CA, Ram AF. Effects of a defective ERAD pathway on growth and heterologous protein production in </a:t>
            </a:r>
            <a:r>
              <a:rPr lang="en-AU" sz="1000" i="1" dirty="0"/>
              <a:t>Aspergillus </a:t>
            </a:r>
            <a:r>
              <a:rPr lang="en-AU" sz="1000" i="1" dirty="0" err="1"/>
              <a:t>niger</a:t>
            </a:r>
            <a:r>
              <a:rPr lang="en-AU" sz="1000" dirty="0"/>
              <a:t>. Appl Microbiol </a:t>
            </a:r>
            <a:r>
              <a:rPr lang="en-AU" sz="1000" dirty="0" err="1"/>
              <a:t>Biotechnol</a:t>
            </a:r>
            <a:r>
              <a:rPr lang="en-AU" sz="1000" dirty="0"/>
              <a:t>. 2011 Jan;89(2):357-73.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AU" sz="1000" dirty="0"/>
              <a:t>Kwon, M.J., </a:t>
            </a:r>
            <a:r>
              <a:rPr lang="en-AU" sz="1000" dirty="0" err="1"/>
              <a:t>Jørgensen</a:t>
            </a:r>
            <a:r>
              <a:rPr lang="en-AU" sz="1000" dirty="0"/>
              <a:t>, T.R., </a:t>
            </a:r>
            <a:r>
              <a:rPr lang="en-AU" sz="1000" dirty="0" err="1"/>
              <a:t>Nitsche</a:t>
            </a:r>
            <a:r>
              <a:rPr lang="en-AU" sz="1000" dirty="0"/>
              <a:t>, B.M. </a:t>
            </a:r>
            <a:r>
              <a:rPr lang="en-AU" sz="1000" i="1" dirty="0"/>
              <a:t>et al.</a:t>
            </a:r>
            <a:r>
              <a:rPr lang="en-AU" sz="1000" dirty="0"/>
              <a:t> The transcriptomic fingerprint of glucoamylase over-expression in </a:t>
            </a:r>
            <a:r>
              <a:rPr lang="en-AU" sz="1000" i="1" dirty="0"/>
              <a:t>Aspergillus </a:t>
            </a:r>
            <a:r>
              <a:rPr lang="en-AU" sz="1000" i="1" dirty="0" err="1"/>
              <a:t>niger</a:t>
            </a:r>
            <a:r>
              <a:rPr lang="en-AU" sz="1000" dirty="0"/>
              <a:t>. </a:t>
            </a:r>
            <a:r>
              <a:rPr lang="en-AU" sz="1000" i="1" dirty="0"/>
              <a:t>BMC Genomics</a:t>
            </a:r>
            <a:r>
              <a:rPr lang="en-AU" sz="1000" dirty="0"/>
              <a:t> </a:t>
            </a:r>
            <a:r>
              <a:rPr lang="en-AU" sz="1000" b="1" dirty="0"/>
              <a:t>13</a:t>
            </a:r>
            <a:r>
              <a:rPr lang="en-AU" sz="1000" dirty="0"/>
              <a:t>, 701 (2012).</a:t>
            </a:r>
          </a:p>
          <a:p>
            <a:endParaRPr lang="en-AU" sz="1000" dirty="0"/>
          </a:p>
        </p:txBody>
      </p:sp>
    </p:spTree>
    <p:extLst>
      <p:ext uri="{BB962C8B-B14F-4D97-AF65-F5344CB8AC3E}">
        <p14:creationId xmlns:p14="http://schemas.microsoft.com/office/powerpoint/2010/main" val="1307652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0FB08E5-7A1A-4536-1803-E660D2CC35B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6355658"/>
              </p:ext>
            </p:extLst>
          </p:nvPr>
        </p:nvGraphicFramePr>
        <p:xfrm>
          <a:off x="2436110" y="890246"/>
          <a:ext cx="7319779" cy="5258098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846578">
                  <a:extLst>
                    <a:ext uri="{9D8B030D-6E8A-4147-A177-3AD203B41FA5}">
                      <a16:colId xmlns:a16="http://schemas.microsoft.com/office/drawing/2014/main" val="4115761342"/>
                    </a:ext>
                  </a:extLst>
                </a:gridCol>
                <a:gridCol w="2105308">
                  <a:extLst>
                    <a:ext uri="{9D8B030D-6E8A-4147-A177-3AD203B41FA5}">
                      <a16:colId xmlns:a16="http://schemas.microsoft.com/office/drawing/2014/main" val="3880652340"/>
                    </a:ext>
                  </a:extLst>
                </a:gridCol>
                <a:gridCol w="518344">
                  <a:extLst>
                    <a:ext uri="{9D8B030D-6E8A-4147-A177-3AD203B41FA5}">
                      <a16:colId xmlns:a16="http://schemas.microsoft.com/office/drawing/2014/main" val="3581606411"/>
                    </a:ext>
                  </a:extLst>
                </a:gridCol>
                <a:gridCol w="518344">
                  <a:extLst>
                    <a:ext uri="{9D8B030D-6E8A-4147-A177-3AD203B41FA5}">
                      <a16:colId xmlns:a16="http://schemas.microsoft.com/office/drawing/2014/main" val="1094179543"/>
                    </a:ext>
                  </a:extLst>
                </a:gridCol>
                <a:gridCol w="210802">
                  <a:extLst>
                    <a:ext uri="{9D8B030D-6E8A-4147-A177-3AD203B41FA5}">
                      <a16:colId xmlns:a16="http://schemas.microsoft.com/office/drawing/2014/main" val="2599455809"/>
                    </a:ext>
                  </a:extLst>
                </a:gridCol>
                <a:gridCol w="210802">
                  <a:extLst>
                    <a:ext uri="{9D8B030D-6E8A-4147-A177-3AD203B41FA5}">
                      <a16:colId xmlns:a16="http://schemas.microsoft.com/office/drawing/2014/main" val="88938448"/>
                    </a:ext>
                  </a:extLst>
                </a:gridCol>
                <a:gridCol w="210802">
                  <a:extLst>
                    <a:ext uri="{9D8B030D-6E8A-4147-A177-3AD203B41FA5}">
                      <a16:colId xmlns:a16="http://schemas.microsoft.com/office/drawing/2014/main" val="1445145874"/>
                    </a:ext>
                  </a:extLst>
                </a:gridCol>
                <a:gridCol w="210802">
                  <a:extLst>
                    <a:ext uri="{9D8B030D-6E8A-4147-A177-3AD203B41FA5}">
                      <a16:colId xmlns:a16="http://schemas.microsoft.com/office/drawing/2014/main" val="1813366209"/>
                    </a:ext>
                  </a:extLst>
                </a:gridCol>
                <a:gridCol w="519087">
                  <a:extLst>
                    <a:ext uri="{9D8B030D-6E8A-4147-A177-3AD203B41FA5}">
                      <a16:colId xmlns:a16="http://schemas.microsoft.com/office/drawing/2014/main" val="15520962"/>
                    </a:ext>
                  </a:extLst>
                </a:gridCol>
                <a:gridCol w="210802">
                  <a:extLst>
                    <a:ext uri="{9D8B030D-6E8A-4147-A177-3AD203B41FA5}">
                      <a16:colId xmlns:a16="http://schemas.microsoft.com/office/drawing/2014/main" val="98089810"/>
                    </a:ext>
                  </a:extLst>
                </a:gridCol>
                <a:gridCol w="210802">
                  <a:extLst>
                    <a:ext uri="{9D8B030D-6E8A-4147-A177-3AD203B41FA5}">
                      <a16:colId xmlns:a16="http://schemas.microsoft.com/office/drawing/2014/main" val="1655691987"/>
                    </a:ext>
                  </a:extLst>
                </a:gridCol>
                <a:gridCol w="210802">
                  <a:extLst>
                    <a:ext uri="{9D8B030D-6E8A-4147-A177-3AD203B41FA5}">
                      <a16:colId xmlns:a16="http://schemas.microsoft.com/office/drawing/2014/main" val="932856003"/>
                    </a:ext>
                  </a:extLst>
                </a:gridCol>
                <a:gridCol w="210802">
                  <a:extLst>
                    <a:ext uri="{9D8B030D-6E8A-4147-A177-3AD203B41FA5}">
                      <a16:colId xmlns:a16="http://schemas.microsoft.com/office/drawing/2014/main" val="1449409390"/>
                    </a:ext>
                  </a:extLst>
                </a:gridCol>
                <a:gridCol w="518344">
                  <a:extLst>
                    <a:ext uri="{9D8B030D-6E8A-4147-A177-3AD203B41FA5}">
                      <a16:colId xmlns:a16="http://schemas.microsoft.com/office/drawing/2014/main" val="730346833"/>
                    </a:ext>
                  </a:extLst>
                </a:gridCol>
                <a:gridCol w="210802">
                  <a:extLst>
                    <a:ext uri="{9D8B030D-6E8A-4147-A177-3AD203B41FA5}">
                      <a16:colId xmlns:a16="http://schemas.microsoft.com/office/drawing/2014/main" val="213519810"/>
                    </a:ext>
                  </a:extLst>
                </a:gridCol>
                <a:gridCol w="396556">
                  <a:extLst>
                    <a:ext uri="{9D8B030D-6E8A-4147-A177-3AD203B41FA5}">
                      <a16:colId xmlns:a16="http://schemas.microsoft.com/office/drawing/2014/main" val="2372057724"/>
                    </a:ext>
                  </a:extLst>
                </a:gridCol>
              </a:tblGrid>
              <a:tr h="129248"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Gen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Description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15h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18h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21h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extLst>
                  <a:ext uri="{0D108BD9-81ED-4DB2-BD59-A6C34878D82A}">
                    <a16:rowId xmlns:a16="http://schemas.microsoft.com/office/drawing/2014/main" val="4066902594"/>
                  </a:ext>
                </a:extLst>
              </a:tr>
              <a:tr h="344660"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Mean count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Log</a:t>
                      </a:r>
                      <a:r>
                        <a:rPr lang="en-US" sz="800" kern="100" baseline="-25000">
                          <a:effectLst/>
                        </a:rPr>
                        <a:t>2</a:t>
                      </a:r>
                      <a:r>
                        <a:rPr lang="en-US" sz="800" kern="100">
                          <a:effectLst/>
                        </a:rPr>
                        <a:t> Fold chang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p-valu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Mean count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Log</a:t>
                      </a:r>
                      <a:r>
                        <a:rPr lang="en-US" sz="800" kern="100" baseline="-25000">
                          <a:effectLst/>
                        </a:rPr>
                        <a:t>2</a:t>
                      </a:r>
                      <a:r>
                        <a:rPr lang="en-US" sz="800" kern="100">
                          <a:effectLst/>
                        </a:rPr>
                        <a:t> Fold chang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p-valu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Mean count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Log</a:t>
                      </a:r>
                      <a:r>
                        <a:rPr lang="en-US" sz="800" kern="100" baseline="-25000">
                          <a:effectLst/>
                        </a:rPr>
                        <a:t>2</a:t>
                      </a:r>
                      <a:r>
                        <a:rPr lang="en-US" sz="800" kern="100">
                          <a:effectLst/>
                        </a:rPr>
                        <a:t> Fold chang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kern="100">
                          <a:effectLst/>
                        </a:rPr>
                        <a:t>p-value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4029994"/>
                  </a:ext>
                </a:extLst>
              </a:tr>
              <a:tr h="258495"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An08g04490</a:t>
                      </a:r>
                      <a:br>
                        <a:rPr lang="en-US" sz="800" kern="100">
                          <a:effectLst/>
                        </a:rPr>
                      </a:br>
                      <a:r>
                        <a:rPr lang="en-US" sz="800" kern="100">
                          <a:effectLst/>
                        </a:rPr>
                        <a:t>(protA)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Secreted lysosomal Pro-Xaa carboxypeptidase</a:t>
                      </a:r>
                      <a:endParaRPr lang="en-DE" sz="800" kern="100">
                        <a:effectLst/>
                      </a:endParaRPr>
                    </a:p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808.39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2.0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9.17E-5</a:t>
                      </a:r>
                      <a:endParaRPr lang="en-DE" sz="800" kern="100">
                        <a:effectLst/>
                      </a:endParaRPr>
                    </a:p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858.78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43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4.49e-22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382.51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46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19e-6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0024147"/>
                  </a:ext>
                </a:extLst>
              </a:tr>
              <a:tr h="344660"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An08g0414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Ortholog(s) have protein kinase activity, role in protein phosphorylation, proteolysis and cytoplasm localization</a:t>
                      </a:r>
                      <a:endParaRPr lang="en-DE" sz="800" kern="100">
                        <a:effectLst/>
                      </a:endParaRPr>
                    </a:p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2290.14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67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179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2323.21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13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4.68e-16</a:t>
                      </a:r>
                      <a:endParaRPr lang="en-DE" sz="800" kern="100">
                        <a:effectLst/>
                      </a:endParaRPr>
                    </a:p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994.01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21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4.51e-5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9439338"/>
                  </a:ext>
                </a:extLst>
              </a:tr>
              <a:tr h="603156"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An08g0325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Ortholog(s) have role in negative regulation of gluconeogenesis, proteasome-mediated ubiquitin-dependent protein catabolic process, protein catabolic process in the vacuole, protein targeting to vacuole</a:t>
                      </a:r>
                      <a:endParaRPr lang="en-DE" sz="800" kern="100">
                        <a:effectLst/>
                      </a:endParaRPr>
                    </a:p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319.52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42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47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533.72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05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2.42e-13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412.91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07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4.88e-5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65239264"/>
                  </a:ext>
                </a:extLst>
              </a:tr>
              <a:tr h="172330"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An01g1411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Phosphatidylserine decarboxylase</a:t>
                      </a:r>
                      <a:endParaRPr lang="en-DE" sz="800" kern="100">
                        <a:effectLst/>
                      </a:endParaRPr>
                    </a:p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2948.06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55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36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788.82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17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37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919.6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13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7.09e-5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53472428"/>
                  </a:ext>
                </a:extLst>
              </a:tr>
              <a:tr h="603156"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An12g0107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 dirty="0">
                          <a:effectLst/>
                        </a:rPr>
                        <a:t>Ortholog(s) have phosphatidylinositol-3-phosphate binding, ubiquitin-protein transferase activity, role in protein ubiquitination and cytosol, fungal-type vacuole membrane, late endosome, nucleus localization</a:t>
                      </a:r>
                      <a:endParaRPr lang="en-DE" sz="800" kern="100" dirty="0">
                        <a:effectLst/>
                      </a:endParaRPr>
                    </a:p>
                    <a:p>
                      <a:r>
                        <a:rPr lang="en-US" sz="800" kern="100" dirty="0">
                          <a:effectLst/>
                        </a:rPr>
                        <a:t> </a:t>
                      </a:r>
                      <a:endParaRPr lang="en-DE" sz="800" kern="100" dirty="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949.99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97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9.3e-2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824.57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84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7.35e-6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606.81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15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3.87e-4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2493203"/>
                  </a:ext>
                </a:extLst>
              </a:tr>
              <a:tr h="603156"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An07g0700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Ortholog(s) have ATP binding, ATPase activity, metallopeptidase activity, role in protein complex assembly, signal peptide processing and m-AAA complex, mitochondrial inner boundary membrane localization</a:t>
                      </a:r>
                      <a:endParaRPr lang="en-DE" sz="800" kern="100">
                        <a:effectLst/>
                      </a:endParaRPr>
                    </a:p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5346.91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35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61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3064.8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09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62</a:t>
                      </a:r>
                      <a:endParaRPr lang="en-DE" sz="800" kern="100">
                        <a:effectLst/>
                      </a:endParaRPr>
                    </a:p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2040.43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19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</a:endParaRPr>
                    </a:p>
                    <a:p>
                      <a:r>
                        <a:rPr lang="en-US" sz="800" kern="100">
                          <a:effectLst/>
                        </a:rPr>
                        <a:t>2.96e-4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75056236"/>
                  </a:ext>
                </a:extLst>
              </a:tr>
              <a:tr h="172330"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An07g08030</a:t>
                      </a:r>
                      <a:br>
                        <a:rPr lang="en-US" sz="800" kern="100">
                          <a:effectLst/>
                        </a:rPr>
                      </a:br>
                      <a:r>
                        <a:rPr lang="en-US" sz="800" kern="100">
                          <a:effectLst/>
                        </a:rPr>
                        <a:t>(pepF)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Putative serine carboxypeptidase</a:t>
                      </a:r>
                      <a:endParaRPr lang="en-DE" sz="800" kern="100">
                        <a:effectLst/>
                      </a:endParaRPr>
                    </a:p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12.77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01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99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02.09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22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59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99.62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11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6.35e-3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75025576"/>
                  </a:ext>
                </a:extLst>
              </a:tr>
              <a:tr h="603156"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An02g03760</a:t>
                      </a:r>
                      <a:br>
                        <a:rPr lang="en-US" sz="800" kern="100">
                          <a:effectLst/>
                        </a:rPr>
                      </a:br>
                      <a:r>
                        <a:rPr lang="en-US" sz="800" kern="100">
                          <a:effectLst/>
                        </a:rPr>
                        <a:t>(pim1)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Ortholog(s) have ATP-dependent peptidase activity, role in chaperone-mediated protein complex assembly, misfolded or incompletely synthesized protein catabolic process and mitochondrial matrix localization</a:t>
                      </a:r>
                      <a:endParaRPr lang="en-DE" sz="800" kern="100">
                        <a:effectLst/>
                      </a:endParaRPr>
                    </a:p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2860.51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37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58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859.62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08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67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075.06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02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2.13e-3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65005428"/>
                  </a:ext>
                </a:extLst>
              </a:tr>
              <a:tr h="258495"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An17g0076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Ortholog(s) have extracellular region localization</a:t>
                      </a:r>
                      <a:endParaRPr lang="en-DE" sz="800" kern="100">
                        <a:effectLst/>
                      </a:endParaRPr>
                    </a:p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248.53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92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8.9e-2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377.1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84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30e-18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385.85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98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9.95e-10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7508904"/>
                  </a:ext>
                </a:extLst>
              </a:tr>
              <a:tr h="258495"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An09g04470</a:t>
                      </a:r>
                      <a:br>
                        <a:rPr lang="en-US" sz="800" kern="100">
                          <a:effectLst/>
                        </a:rPr>
                      </a:br>
                      <a:r>
                        <a:rPr lang="en-US" sz="800" kern="100">
                          <a:effectLst/>
                        </a:rPr>
                        <a:t>(casB)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Ortholog(s) have calcium-dependent cysteine-type endopeptidase activity</a:t>
                      </a:r>
                      <a:endParaRPr lang="en-DE" sz="800" kern="100">
                        <a:effectLst/>
                      </a:endParaRPr>
                    </a:p>
                    <a:p>
                      <a:r>
                        <a:rPr lang="en-US" sz="800" kern="100">
                          <a:effectLst/>
                        </a:rPr>
                        <a:t> 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049.94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02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6.5e-2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915.01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0.71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17e-5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687.27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kern="100">
                          <a:effectLst/>
                        </a:rPr>
                        <a:t>1.05</a:t>
                      </a:r>
                      <a:endParaRPr lang="en-DE" sz="800" kern="10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gridSpan="2">
                  <a:txBody>
                    <a:bodyPr/>
                    <a:lstStyle/>
                    <a:p>
                      <a:r>
                        <a:rPr lang="en-US" sz="800" kern="100" dirty="0">
                          <a:effectLst/>
                        </a:rPr>
                        <a:t>2.88e-3</a:t>
                      </a:r>
                      <a:endParaRPr lang="en-DE" sz="800" kern="100" dirty="0">
                        <a:effectLst/>
                        <a:latin typeface="Helvetica" pitchFamily="2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48468" marR="48468" marT="0" marB="0"/>
                </a:tc>
                <a:tc hMerge="1">
                  <a:txBody>
                    <a:bodyPr/>
                    <a:lstStyle/>
                    <a:p>
                      <a:endParaRPr lang="en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916252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A87B957F-1AE4-C764-5CD4-E463CEA797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50101" y="259304"/>
            <a:ext cx="7405787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DE" sz="1000" b="1" dirty="0"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7 (iv)</a:t>
            </a:r>
            <a:r>
              <a:rPr kumimoji="0" lang="en-US" altLang="en-D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kumimoji="0" lang="en-US" altLang="en-D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Ten proteases found to be upregulated in the collagen secreting strain TM30.4 at 21h cultivation, cross referenced to a list of 259 putative annotated proteases. Green shading highlights the proteases above the threshold of a log</a:t>
            </a:r>
            <a:r>
              <a:rPr kumimoji="0" lang="en-US" altLang="en-DE" sz="1000" b="0" i="0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kumimoji="0" lang="en-US" altLang="en-D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fold-change higher than 1.0 with a multiple hypothesis corrected p-value below 0.05 indicating statistical significance.</a:t>
            </a:r>
            <a:endParaRPr kumimoji="0" lang="en-US" altLang="en-D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13B8A84-AFC1-4090-A721-7AC6F72A5B9A}"/>
              </a:ext>
            </a:extLst>
          </p:cNvPr>
          <p:cNvSpPr txBox="1"/>
          <p:nvPr/>
        </p:nvSpPr>
        <p:spPr>
          <a:xfrm>
            <a:off x="2461098" y="6245157"/>
            <a:ext cx="65870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Dong, Z., Yang, S. &amp; Lee, B.H. Bioinformatic mapping of a more precise </a:t>
            </a:r>
            <a:r>
              <a:rPr lang="en-AU" sz="1000" i="1" dirty="0"/>
              <a:t>Aspergillus </a:t>
            </a:r>
            <a:r>
              <a:rPr lang="en-AU" sz="1000" i="1" dirty="0" err="1"/>
              <a:t>niger</a:t>
            </a:r>
            <a:r>
              <a:rPr lang="en-AU" sz="1000" dirty="0"/>
              <a:t> degradome. </a:t>
            </a:r>
            <a:r>
              <a:rPr lang="en-AU" sz="1000" i="1" dirty="0"/>
              <a:t>Sci Rep</a:t>
            </a:r>
            <a:r>
              <a:rPr lang="en-AU" sz="1000" dirty="0"/>
              <a:t> </a:t>
            </a:r>
            <a:r>
              <a:rPr lang="en-AU" sz="1000" b="1" dirty="0"/>
              <a:t>11</a:t>
            </a:r>
            <a:r>
              <a:rPr lang="en-AU" sz="1000" dirty="0"/>
              <a:t>, 693 (2021).</a:t>
            </a:r>
          </a:p>
        </p:txBody>
      </p:sp>
    </p:spTree>
    <p:extLst>
      <p:ext uri="{BB962C8B-B14F-4D97-AF65-F5344CB8AC3E}">
        <p14:creationId xmlns:p14="http://schemas.microsoft.com/office/powerpoint/2010/main" val="2879227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95</Words>
  <Application>Microsoft Office PowerPoint</Application>
  <PresentationFormat>Widescreen</PresentationFormat>
  <Paragraphs>47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2" baseType="lpstr">
      <vt:lpstr>MS Mincho</vt:lpstr>
      <vt:lpstr>Aptos</vt:lpstr>
      <vt:lpstr>Aptos Display</vt:lpstr>
      <vt:lpstr>Arial</vt:lpstr>
      <vt:lpstr>Calibri</vt:lpstr>
      <vt:lpstr>Helvetica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U-Pseudonym 1517372033116741</dc:creator>
  <cp:lastModifiedBy>tom.morris</cp:lastModifiedBy>
  <cp:revision>4</cp:revision>
  <dcterms:created xsi:type="dcterms:W3CDTF">2024-11-19T17:31:32Z</dcterms:created>
  <dcterms:modified xsi:type="dcterms:W3CDTF">2025-07-16T09:59:40Z</dcterms:modified>
</cp:coreProperties>
</file>